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2562"/>
  </p:normalViewPr>
  <p:slideViewPr>
    <p:cSldViewPr snapToGrid="0" snapToObjects="1">
      <p:cViewPr varScale="1">
        <p:scale>
          <a:sx n="63" d="100"/>
          <a:sy n="63" d="100"/>
        </p:scale>
        <p:origin x="2232" y="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8398D6-B251-B74C-B82C-25B71A955EDB}" type="datetimeFigureOut">
              <a:rPr lang="en-US" smtClean="0"/>
              <a:t>6/3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AB6A6B-8A44-E145-9098-06A312189C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1970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40624-360E-F24A-A9D9-BB545F660263}" type="datetimeFigureOut">
              <a:rPr lang="en-US" smtClean="0"/>
              <a:t>6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707A2-935B-D949-A8BE-6C544A744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717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40624-360E-F24A-A9D9-BB545F660263}" type="datetimeFigureOut">
              <a:rPr lang="en-US" smtClean="0"/>
              <a:t>6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707A2-935B-D949-A8BE-6C544A744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68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40624-360E-F24A-A9D9-BB545F660263}" type="datetimeFigureOut">
              <a:rPr lang="en-US" smtClean="0"/>
              <a:t>6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707A2-935B-D949-A8BE-6C544A744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943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40624-360E-F24A-A9D9-BB545F660263}" type="datetimeFigureOut">
              <a:rPr lang="en-US" smtClean="0"/>
              <a:t>6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707A2-935B-D949-A8BE-6C544A744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386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1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40624-360E-F24A-A9D9-BB545F660263}" type="datetimeFigureOut">
              <a:rPr lang="en-US" smtClean="0"/>
              <a:t>6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707A2-935B-D949-A8BE-6C544A744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147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40624-360E-F24A-A9D9-BB545F660263}" type="datetimeFigureOut">
              <a:rPr lang="en-US" smtClean="0"/>
              <a:t>6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707A2-935B-D949-A8BE-6C544A744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222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8"/>
            <a:ext cx="303133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40624-360E-F24A-A9D9-BB545F660263}" type="datetimeFigureOut">
              <a:rPr lang="en-US" smtClean="0"/>
              <a:t>6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707A2-935B-D949-A8BE-6C544A744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85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40624-360E-F24A-A9D9-BB545F660263}" type="datetimeFigureOut">
              <a:rPr lang="en-US" smtClean="0"/>
              <a:t>6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707A2-935B-D949-A8BE-6C544A744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113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40624-360E-F24A-A9D9-BB545F660263}" type="datetimeFigureOut">
              <a:rPr lang="en-US" smtClean="0"/>
              <a:t>6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707A2-935B-D949-A8BE-6C544A744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50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9"/>
            <a:ext cx="2256235" cy="154940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40624-360E-F24A-A9D9-BB545F660263}" type="datetimeFigureOut">
              <a:rPr lang="en-US" smtClean="0"/>
              <a:t>6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707A2-935B-D949-A8BE-6C544A744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272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40624-360E-F24A-A9D9-BB545F660263}" type="datetimeFigureOut">
              <a:rPr lang="en-US" smtClean="0"/>
              <a:t>6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707A2-935B-D949-A8BE-6C544A744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285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D40624-360E-F24A-A9D9-BB545F660263}" type="datetimeFigureOut">
              <a:rPr lang="en-US" smtClean="0"/>
              <a:t>6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0707A2-935B-D949-A8BE-6C544A744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986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238488" y="137509"/>
            <a:ext cx="6106520" cy="9083520"/>
            <a:chOff x="580030" y="71307"/>
            <a:chExt cx="6106520" cy="9083520"/>
          </a:xfrm>
        </p:grpSpPr>
        <p:grpSp>
          <p:nvGrpSpPr>
            <p:cNvPr id="66" name="Group 65"/>
            <p:cNvGrpSpPr/>
            <p:nvPr/>
          </p:nvGrpSpPr>
          <p:grpSpPr>
            <a:xfrm>
              <a:off x="580030" y="71307"/>
              <a:ext cx="6106520" cy="9083520"/>
              <a:chOff x="580030" y="261806"/>
              <a:chExt cx="5562601" cy="10155379"/>
            </a:xfrm>
          </p:grpSpPr>
          <p:pic>
            <p:nvPicPr>
              <p:cNvPr id="34" name="Picture 8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020"/>
              <a:stretch/>
            </p:blipFill>
            <p:spPr bwMode="auto">
              <a:xfrm>
                <a:off x="685801" y="6053098"/>
                <a:ext cx="5456830" cy="435198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" name="Picture 7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611"/>
              <a:stretch/>
            </p:blipFill>
            <p:spPr bwMode="auto">
              <a:xfrm>
                <a:off x="580030" y="1079519"/>
                <a:ext cx="5562600" cy="440688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3200400" y="261806"/>
                <a:ext cx="84830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+</a:t>
                </a:r>
              </a:p>
            </p:txBody>
          </p:sp>
          <p:cxnSp>
            <p:nvCxnSpPr>
              <p:cNvPr id="8" name="Straight Connector 7"/>
              <p:cNvCxnSpPr/>
              <p:nvPr/>
            </p:nvCxnSpPr>
            <p:spPr>
              <a:xfrm>
                <a:off x="1828800" y="2070119"/>
                <a:ext cx="38813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/>
              <p:cNvCxnSpPr/>
              <p:nvPr/>
            </p:nvCxnSpPr>
            <p:spPr>
              <a:xfrm>
                <a:off x="3160220" y="1295400"/>
                <a:ext cx="38813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/>
              <p:cNvCxnSpPr/>
              <p:nvPr/>
            </p:nvCxnSpPr>
            <p:spPr>
              <a:xfrm>
                <a:off x="3167263" y="1079519"/>
                <a:ext cx="881446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4945957" y="1371600"/>
                <a:ext cx="38813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/>
              <p:cNvCxnSpPr/>
              <p:nvPr/>
            </p:nvCxnSpPr>
            <p:spPr>
              <a:xfrm>
                <a:off x="4953000" y="1083139"/>
                <a:ext cx="881446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>
                <a:off x="1894265" y="1844509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3444024" y="838200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3213193" y="1072695"/>
                <a:ext cx="2744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4989092" y="1110734"/>
                <a:ext cx="2744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5309809" y="838200"/>
                <a:ext cx="2744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867103" y="5652988"/>
                <a:ext cx="175400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+Foxp3+</a:t>
                </a:r>
              </a:p>
            </p:txBody>
          </p:sp>
          <p:cxnSp>
            <p:nvCxnSpPr>
              <p:cNvPr id="22" name="Straight Connector 21"/>
              <p:cNvCxnSpPr/>
              <p:nvPr/>
            </p:nvCxnSpPr>
            <p:spPr>
              <a:xfrm>
                <a:off x="3074857" y="7100788"/>
                <a:ext cx="38813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>
                <a:off x="3107630" y="6414988"/>
                <a:ext cx="881446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>
                <a:off x="3660576" y="6719788"/>
                <a:ext cx="38813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/>
              <p:cNvCxnSpPr/>
              <p:nvPr/>
            </p:nvCxnSpPr>
            <p:spPr>
              <a:xfrm>
                <a:off x="4811470" y="6803441"/>
                <a:ext cx="38813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/>
              <p:cNvCxnSpPr/>
              <p:nvPr/>
            </p:nvCxnSpPr>
            <p:spPr>
              <a:xfrm>
                <a:off x="5422871" y="6554669"/>
                <a:ext cx="38813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" name="TextBox 26"/>
              <p:cNvSpPr txBox="1"/>
              <p:nvPr/>
            </p:nvSpPr>
            <p:spPr>
              <a:xfrm>
                <a:off x="3131674" y="6859469"/>
                <a:ext cx="2744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3722274" y="6490137"/>
                <a:ext cx="2744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3456816" y="6170760"/>
                <a:ext cx="2744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868287" y="6547516"/>
                <a:ext cx="2744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5456585" y="6312508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685800" y="261806"/>
                <a:ext cx="37061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685800" y="5652988"/>
                <a:ext cx="37061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8692448">
                <a:off x="4437210" y="4498601"/>
                <a:ext cx="603726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Sham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 rot="18692448">
                <a:off x="4951107" y="4475921"/>
                <a:ext cx="489662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CLP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 rot="18692448">
                <a:off x="4984631" y="4634681"/>
                <a:ext cx="1044351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CLP+EX527</a:t>
                </a: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1676400" y="5116319"/>
                <a:ext cx="493847" cy="4129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12h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4953000" y="5116319"/>
                <a:ext cx="493847" cy="4129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48h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8692448">
                <a:off x="2667873" y="4477559"/>
                <a:ext cx="603726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Sham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rot="18692448">
                <a:off x="3220791" y="4453241"/>
                <a:ext cx="489662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CLP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 rot="18692448">
                <a:off x="3239899" y="4638148"/>
                <a:ext cx="1044351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CLP+EX527</a:t>
                </a: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3354287" y="5116319"/>
                <a:ext cx="493847" cy="4129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30h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 rot="18692448">
                <a:off x="1837111" y="4450816"/>
                <a:ext cx="648380" cy="252326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b="1" dirty="0">
                    <a:latin typeface="Arial"/>
                    <a:cs typeface="Arial"/>
                  </a:rPr>
                  <a:t>CLP</a:t>
                </a: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 rot="18692448">
                <a:off x="4428432" y="9423906"/>
                <a:ext cx="603726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Sham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 rot="18692448">
                <a:off x="4976559" y="9363874"/>
                <a:ext cx="489662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CLP</a:t>
                </a: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 rot="18692448">
                <a:off x="5010083" y="9522634"/>
                <a:ext cx="1044351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CLP+EX527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1701852" y="10004272"/>
                <a:ext cx="493847" cy="4129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12h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4978452" y="10004272"/>
                <a:ext cx="493847" cy="4129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48h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 rot="18692448">
                <a:off x="2698116" y="9382550"/>
                <a:ext cx="603726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Sham</a:t>
                </a: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rot="18692448">
                <a:off x="3246243" y="9341194"/>
                <a:ext cx="489662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CLP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 rot="18692448">
                <a:off x="3265351" y="9526101"/>
                <a:ext cx="1044351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CLP+EX527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3379739" y="10004272"/>
                <a:ext cx="493847" cy="4129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30h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 rot="18692448">
                <a:off x="1423403" y="9386554"/>
                <a:ext cx="603726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Sham</a:t>
                </a: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 rot="18692448">
                <a:off x="1952856" y="9363874"/>
                <a:ext cx="489662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CLP</a:t>
                </a:r>
              </a:p>
            </p:txBody>
          </p:sp>
        </p:grpSp>
        <p:sp>
          <p:nvSpPr>
            <p:cNvPr id="2" name="Rectangle 1"/>
            <p:cNvSpPr/>
            <p:nvPr/>
          </p:nvSpPr>
          <p:spPr>
            <a:xfrm rot="19517424">
              <a:off x="1446613" y="3787760"/>
              <a:ext cx="662978" cy="3776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3" name="TextBox 52"/>
          <p:cNvSpPr txBox="1"/>
          <p:nvPr/>
        </p:nvSpPr>
        <p:spPr>
          <a:xfrm rot="18692448">
            <a:off x="1571336" y="3838535"/>
            <a:ext cx="804971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400" b="1" dirty="0">
                <a:latin typeface="Arial"/>
                <a:cs typeface="Arial"/>
              </a:rPr>
              <a:t>Sham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-50104" y="-99178"/>
            <a:ext cx="26179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2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0310667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8</TotalTime>
  <Words>40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ana Martin</dc:creator>
  <cp:lastModifiedBy>Vidula T. Vachharajani</cp:lastModifiedBy>
  <cp:revision>42</cp:revision>
  <dcterms:created xsi:type="dcterms:W3CDTF">2017-09-06T01:01:50Z</dcterms:created>
  <dcterms:modified xsi:type="dcterms:W3CDTF">2018-06-03T11:34:25Z</dcterms:modified>
</cp:coreProperties>
</file>